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7160"/>
  </p:normalViewPr>
  <p:slideViewPr>
    <p:cSldViewPr snapToGrid="0" snapToObjects="1">
      <p:cViewPr varScale="1">
        <p:scale>
          <a:sx n="124" d="100"/>
          <a:sy n="124" d="100"/>
        </p:scale>
        <p:origin x="20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567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202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219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448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15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8419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474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457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6957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393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236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A861A9-AA4A-B74A-8D10-FE79CA0D0DB4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7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>
            <a:extLst>
              <a:ext uri="{FF2B5EF4-FFF2-40B4-BE49-F238E27FC236}">
                <a16:creationId xmlns:a16="http://schemas.microsoft.com/office/drawing/2014/main" id="{C2F8F7FC-7FA5-564D-9341-DB3579E49AE0}"/>
              </a:ext>
            </a:extLst>
          </p:cNvPr>
          <p:cNvSpPr txBox="1"/>
          <p:nvPr/>
        </p:nvSpPr>
        <p:spPr>
          <a:xfrm>
            <a:off x="4473542" y="629350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A3DE05C-1F1E-8F48-BEA5-B4CB94119431}"/>
              </a:ext>
            </a:extLst>
          </p:cNvPr>
          <p:cNvGrpSpPr/>
          <p:nvPr/>
        </p:nvGrpSpPr>
        <p:grpSpPr>
          <a:xfrm>
            <a:off x="2993322" y="2357874"/>
            <a:ext cx="3919356" cy="2142253"/>
            <a:chOff x="2993322" y="2357874"/>
            <a:chExt cx="3919356" cy="2142253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018289B3-8E3D-F047-992B-386BF6ACCE6D}"/>
                </a:ext>
              </a:extLst>
            </p:cNvPr>
            <p:cNvSpPr/>
            <p:nvPr/>
          </p:nvSpPr>
          <p:spPr>
            <a:xfrm>
              <a:off x="2993322" y="2588708"/>
              <a:ext cx="1900230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A5C85EC5-C911-C149-9DEF-CDE22DC721EE}"/>
                </a:ext>
              </a:extLst>
            </p:cNvPr>
            <p:cNvSpPr/>
            <p:nvPr/>
          </p:nvSpPr>
          <p:spPr>
            <a:xfrm>
              <a:off x="4044336" y="3559436"/>
              <a:ext cx="151009" cy="151009"/>
            </a:xfrm>
            <a:prstGeom prst="ellipse">
              <a:avLst/>
            </a:prstGeom>
            <a:noFill/>
            <a:ln w="317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56159984-FFFE-C647-966B-0F5211F350D2}"/>
                </a:ext>
              </a:extLst>
            </p:cNvPr>
            <p:cNvGrpSpPr/>
            <p:nvPr/>
          </p:nvGrpSpPr>
          <p:grpSpPr>
            <a:xfrm>
              <a:off x="3321423" y="2941016"/>
              <a:ext cx="1222375" cy="1212850"/>
              <a:chOff x="4552950" y="2711450"/>
              <a:chExt cx="1222375" cy="1212850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6DCEB672-4E3F-1642-9B01-9C5F7D2D13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83708" y="3087180"/>
                <a:ext cx="532867" cy="64344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031A30D4-DC6D-BC4D-9DB9-FADC0C262A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7108" y="3728530"/>
                <a:ext cx="158217" cy="8464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D685A5F4-1C1A-674E-8E18-4762BAD12A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3933" y="3728530"/>
                <a:ext cx="66142" cy="19577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29A5F721-6610-9E45-8582-98B1FF8E9DE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86883" y="2873375"/>
                <a:ext cx="228067" cy="20745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3B064C82-2177-8246-9D5B-D424C901D2C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15483" y="2711450"/>
                <a:ext cx="78842" cy="16618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AB42D6EE-E5FF-404B-B8E7-0EA7EC28CD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18125" y="2825750"/>
                <a:ext cx="149225" cy="444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33E410E2-9A7C-9C49-86C1-49CA54D3AB5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800600" y="3082925"/>
                <a:ext cx="288926" cy="25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id="{C4C60EF0-51A2-3642-9F60-DE4215200F8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810125" y="2876550"/>
                <a:ext cx="1" cy="2317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8810D440-5678-0044-B4F5-40CFEB643D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51375" y="3108325"/>
                <a:ext cx="158751" cy="1428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EA77153E-02A1-EE49-89A2-8B45653D3BA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552950" y="3092450"/>
                <a:ext cx="104776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E69A89B4-AE6E-8440-B4EF-C0813A47EA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22800" y="3248025"/>
                <a:ext cx="28576" cy="1968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id="{57D2978B-7FE7-6B42-BB29-CB43B52523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59300" y="3438525"/>
                <a:ext cx="66676" cy="1301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FEB89C66-C5E3-F145-B8D2-01A4ADB6F36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622801" y="3438525"/>
                <a:ext cx="34924" cy="1555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173E83FE-29FF-A44A-88C0-AD7DC71EC7B5}"/>
                </a:ext>
              </a:extLst>
            </p:cNvPr>
            <p:cNvGrpSpPr/>
            <p:nvPr/>
          </p:nvGrpSpPr>
          <p:grpSpPr>
            <a:xfrm>
              <a:off x="3374412" y="3083187"/>
              <a:ext cx="1029775" cy="896425"/>
              <a:chOff x="4605939" y="2853621"/>
              <a:chExt cx="1029775" cy="896425"/>
            </a:xfrm>
            <a:solidFill>
              <a:schemeClr val="tx1"/>
            </a:solidFill>
          </p:grpSpPr>
          <p:sp>
            <p:nvSpPr>
              <p:cNvPr id="118" name="Oval 117">
                <a:extLst>
                  <a:ext uri="{FF2B5EF4-FFF2-40B4-BE49-F238E27FC236}">
                    <a16:creationId xmlns:a16="http://schemas.microsoft.com/office/drawing/2014/main" id="{B3BF687D-C6C2-EF4C-A90A-1DB094B936BF}"/>
                  </a:ext>
                </a:extLst>
              </p:cNvPr>
              <p:cNvSpPr/>
              <p:nvPr/>
            </p:nvSpPr>
            <p:spPr>
              <a:xfrm>
                <a:off x="4793264" y="3088571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47" name="Oval 146">
                <a:extLst>
                  <a:ext uri="{FF2B5EF4-FFF2-40B4-BE49-F238E27FC236}">
                    <a16:creationId xmlns:a16="http://schemas.microsoft.com/office/drawing/2014/main" id="{45DE154F-2412-644B-84CF-CB4A6005A746}"/>
                  </a:ext>
                </a:extLst>
              </p:cNvPr>
              <p:cNvSpPr/>
              <p:nvPr/>
            </p:nvSpPr>
            <p:spPr>
              <a:xfrm>
                <a:off x="5298089" y="2853621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48" name="Oval 147">
                <a:extLst>
                  <a:ext uri="{FF2B5EF4-FFF2-40B4-BE49-F238E27FC236}">
                    <a16:creationId xmlns:a16="http://schemas.microsoft.com/office/drawing/2014/main" id="{B674F34C-F035-014D-9CEF-10DDBA355286}"/>
                  </a:ext>
                </a:extLst>
              </p:cNvPr>
              <p:cNvSpPr/>
              <p:nvPr/>
            </p:nvSpPr>
            <p:spPr>
              <a:xfrm>
                <a:off x="5066314" y="3059996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50" name="Oval 149">
                <a:extLst>
                  <a:ext uri="{FF2B5EF4-FFF2-40B4-BE49-F238E27FC236}">
                    <a16:creationId xmlns:a16="http://schemas.microsoft.com/office/drawing/2014/main" id="{57AEE599-E9FF-7148-BB2D-7C23132B00AD}"/>
                  </a:ext>
                </a:extLst>
              </p:cNvPr>
              <p:cNvSpPr/>
              <p:nvPr/>
            </p:nvSpPr>
            <p:spPr>
              <a:xfrm>
                <a:off x="5329839" y="3387021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51" name="Oval 150">
                <a:extLst>
                  <a:ext uri="{FF2B5EF4-FFF2-40B4-BE49-F238E27FC236}">
                    <a16:creationId xmlns:a16="http://schemas.microsoft.com/office/drawing/2014/main" id="{57A9EA24-CC29-5840-8370-BF7E92BE3402}"/>
                  </a:ext>
                </a:extLst>
              </p:cNvPr>
              <p:cNvSpPr/>
              <p:nvPr/>
            </p:nvSpPr>
            <p:spPr>
              <a:xfrm>
                <a:off x="5599714" y="3714046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52" name="Oval 151">
                <a:extLst>
                  <a:ext uri="{FF2B5EF4-FFF2-40B4-BE49-F238E27FC236}">
                    <a16:creationId xmlns:a16="http://schemas.microsoft.com/office/drawing/2014/main" id="{DE643BBB-BBFC-6242-9F3D-E233BD2C990A}"/>
                  </a:ext>
                </a:extLst>
              </p:cNvPr>
              <p:cNvSpPr/>
              <p:nvPr/>
            </p:nvSpPr>
            <p:spPr>
              <a:xfrm>
                <a:off x="4634514" y="3221921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53" name="Oval 152">
                <a:extLst>
                  <a:ext uri="{FF2B5EF4-FFF2-40B4-BE49-F238E27FC236}">
                    <a16:creationId xmlns:a16="http://schemas.microsoft.com/office/drawing/2014/main" id="{AD5B93DD-707E-C743-B80B-F8A2931A6B61}"/>
                  </a:ext>
                </a:extLst>
              </p:cNvPr>
              <p:cNvSpPr/>
              <p:nvPr/>
            </p:nvSpPr>
            <p:spPr>
              <a:xfrm>
                <a:off x="4605939" y="3421946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154" name="Oval 153">
              <a:extLst>
                <a:ext uri="{FF2B5EF4-FFF2-40B4-BE49-F238E27FC236}">
                  <a16:creationId xmlns:a16="http://schemas.microsoft.com/office/drawing/2014/main" id="{155C3B34-C455-AC49-8CF2-A4E77A0F5786}"/>
                </a:ext>
              </a:extLst>
            </p:cNvPr>
            <p:cNvSpPr/>
            <p:nvPr/>
          </p:nvSpPr>
          <p:spPr>
            <a:xfrm>
              <a:off x="4123712" y="2908562"/>
              <a:ext cx="69156" cy="69156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5" name="Oval 154">
              <a:extLst>
                <a:ext uri="{FF2B5EF4-FFF2-40B4-BE49-F238E27FC236}">
                  <a16:creationId xmlns:a16="http://schemas.microsoft.com/office/drawing/2014/main" id="{E6AE34B9-6306-184B-8409-74507A73D5E5}"/>
                </a:ext>
              </a:extLst>
            </p:cNvPr>
            <p:cNvSpPr/>
            <p:nvPr/>
          </p:nvSpPr>
          <p:spPr>
            <a:xfrm>
              <a:off x="4196737" y="3019687"/>
              <a:ext cx="69156" cy="69156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6" name="Oval 155">
              <a:extLst>
                <a:ext uri="{FF2B5EF4-FFF2-40B4-BE49-F238E27FC236}">
                  <a16:creationId xmlns:a16="http://schemas.microsoft.com/office/drawing/2014/main" id="{797C09D2-B4CF-6D49-987C-543680334EB0}"/>
                </a:ext>
              </a:extLst>
            </p:cNvPr>
            <p:cNvSpPr/>
            <p:nvPr/>
          </p:nvSpPr>
          <p:spPr>
            <a:xfrm>
              <a:off x="4511062" y="4007112"/>
              <a:ext cx="69156" cy="69156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7" name="Oval 156">
              <a:extLst>
                <a:ext uri="{FF2B5EF4-FFF2-40B4-BE49-F238E27FC236}">
                  <a16:creationId xmlns:a16="http://schemas.microsoft.com/office/drawing/2014/main" id="{543DB9C9-7E91-DD49-AB15-247B916B993C}"/>
                </a:ext>
              </a:extLst>
            </p:cNvPr>
            <p:cNvSpPr/>
            <p:nvPr/>
          </p:nvSpPr>
          <p:spPr>
            <a:xfrm>
              <a:off x="4415812" y="4111887"/>
              <a:ext cx="69156" cy="69156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8" name="Oval 157">
              <a:extLst>
                <a:ext uri="{FF2B5EF4-FFF2-40B4-BE49-F238E27FC236}">
                  <a16:creationId xmlns:a16="http://schemas.microsoft.com/office/drawing/2014/main" id="{59E0D1FD-0071-294F-BD9E-DAF2A81AAD5F}"/>
                </a:ext>
              </a:extLst>
            </p:cNvPr>
            <p:cNvSpPr/>
            <p:nvPr/>
          </p:nvSpPr>
          <p:spPr>
            <a:xfrm>
              <a:off x="3542687" y="3060962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9" name="Oval 158">
              <a:extLst>
                <a:ext uri="{FF2B5EF4-FFF2-40B4-BE49-F238E27FC236}">
                  <a16:creationId xmlns:a16="http://schemas.microsoft.com/office/drawing/2014/main" id="{B8D5E375-0270-0841-A449-CADB94D8B4A3}"/>
                </a:ext>
              </a:extLst>
            </p:cNvPr>
            <p:cNvSpPr/>
            <p:nvPr/>
          </p:nvSpPr>
          <p:spPr>
            <a:xfrm>
              <a:off x="3285512" y="3276862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0" name="Oval 159">
              <a:extLst>
                <a:ext uri="{FF2B5EF4-FFF2-40B4-BE49-F238E27FC236}">
                  <a16:creationId xmlns:a16="http://schemas.microsoft.com/office/drawing/2014/main" id="{478F90FB-45E4-4E4C-962D-AB16F7CBD317}"/>
                </a:ext>
              </a:extLst>
            </p:cNvPr>
            <p:cNvSpPr/>
            <p:nvPr/>
          </p:nvSpPr>
          <p:spPr>
            <a:xfrm>
              <a:off x="3285512" y="3768987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1" name="Oval 160">
              <a:extLst>
                <a:ext uri="{FF2B5EF4-FFF2-40B4-BE49-F238E27FC236}">
                  <a16:creationId xmlns:a16="http://schemas.microsoft.com/office/drawing/2014/main" id="{21FD1B7C-19E7-B043-A2E6-D112DFAEC824}"/>
                </a:ext>
              </a:extLst>
            </p:cNvPr>
            <p:cNvSpPr/>
            <p:nvPr/>
          </p:nvSpPr>
          <p:spPr>
            <a:xfrm>
              <a:off x="3383937" y="3772162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BFD8865A-3DDD-0E44-9721-16EB5880D582}"/>
                </a:ext>
              </a:extLst>
            </p:cNvPr>
            <p:cNvSpPr txBox="1"/>
            <p:nvPr/>
          </p:nvSpPr>
          <p:spPr>
            <a:xfrm>
              <a:off x="4027124" y="2749453"/>
              <a:ext cx="3513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ROX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A99CF8E5-69EE-3D44-8A92-1AAE4C15FE3C}"/>
                </a:ext>
              </a:extLst>
            </p:cNvPr>
            <p:cNvSpPr txBox="1"/>
            <p:nvPr/>
          </p:nvSpPr>
          <p:spPr>
            <a:xfrm>
              <a:off x="4205047" y="2946303"/>
              <a:ext cx="32573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TYL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C2DE8F12-B042-BD4D-9638-73D48CF8B0DE}"/>
                </a:ext>
              </a:extLst>
            </p:cNvPr>
            <p:cNvSpPr txBox="1"/>
            <p:nvPr/>
          </p:nvSpPr>
          <p:spPr>
            <a:xfrm>
              <a:off x="4505777" y="4003578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ZM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87AE983F-8F84-EA4E-BE37-6E3512950E4F}"/>
                </a:ext>
              </a:extLst>
            </p:cNvPr>
            <p:cNvSpPr txBox="1"/>
            <p:nvPr/>
          </p:nvSpPr>
          <p:spPr>
            <a:xfrm>
              <a:off x="4312935" y="4175028"/>
              <a:ext cx="3385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JSM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81D4ADC-1CEB-E344-9F2B-B95F5D5D8F28}"/>
                </a:ext>
              </a:extLst>
            </p:cNvPr>
            <p:cNvSpPr txBox="1"/>
            <p:nvPr/>
          </p:nvSpPr>
          <p:spPr>
            <a:xfrm>
              <a:off x="3408768" y="2914553"/>
              <a:ext cx="3561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ERM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E2384F57-096C-2845-A500-E6EDA1253120}"/>
                </a:ext>
              </a:extLst>
            </p:cNvPr>
            <p:cNvSpPr txBox="1"/>
            <p:nvPr/>
          </p:nvSpPr>
          <p:spPr>
            <a:xfrm>
              <a:off x="3093797" y="3133628"/>
              <a:ext cx="32573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F6D6AF16-7563-4E45-B0CA-C50FBECDA192}"/>
                </a:ext>
              </a:extLst>
            </p:cNvPr>
            <p:cNvSpPr txBox="1"/>
            <p:nvPr/>
          </p:nvSpPr>
          <p:spPr>
            <a:xfrm>
              <a:off x="3068273" y="3835303"/>
              <a:ext cx="3513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SPM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96BDB30F-74DD-3C49-A840-0CD18424F04C}"/>
                </a:ext>
              </a:extLst>
            </p:cNvPr>
            <p:cNvSpPr txBox="1"/>
            <p:nvPr/>
          </p:nvSpPr>
          <p:spPr>
            <a:xfrm>
              <a:off x="3282600" y="3835303"/>
              <a:ext cx="3481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LM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F884A530-2FED-0D48-B6B0-17D09A7E4A1E}"/>
                </a:ext>
              </a:extLst>
            </p:cNvPr>
            <p:cNvSpPr/>
            <p:nvPr/>
          </p:nvSpPr>
          <p:spPr>
            <a:xfrm>
              <a:off x="5005166" y="2590170"/>
              <a:ext cx="1900230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8B7CE627-9857-584E-A0F2-75B6BBFD3DDF}"/>
                </a:ext>
              </a:extLst>
            </p:cNvPr>
            <p:cNvSpPr/>
            <p:nvPr/>
          </p:nvSpPr>
          <p:spPr>
            <a:xfrm>
              <a:off x="6060705" y="3480794"/>
              <a:ext cx="151009" cy="151009"/>
            </a:xfrm>
            <a:prstGeom prst="ellipse">
              <a:avLst/>
            </a:prstGeom>
            <a:noFill/>
            <a:ln w="317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47DC60E-33A7-D545-8A74-1F34D27178DE}"/>
                </a:ext>
              </a:extLst>
            </p:cNvPr>
            <p:cNvSpPr txBox="1"/>
            <p:nvPr/>
          </p:nvSpPr>
          <p:spPr>
            <a:xfrm>
              <a:off x="5547705" y="2750186"/>
              <a:ext cx="3513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ROX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D08E394-DC51-3249-9F63-7813F82A7BA1}"/>
                </a:ext>
              </a:extLst>
            </p:cNvPr>
            <p:cNvSpPr txBox="1"/>
            <p:nvPr/>
          </p:nvSpPr>
          <p:spPr>
            <a:xfrm>
              <a:off x="6411428" y="2950211"/>
              <a:ext cx="32573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TYL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05C0FF0-464A-FF4E-A2B0-BE12C8688E6C}"/>
                </a:ext>
              </a:extLst>
            </p:cNvPr>
            <p:cNvSpPr txBox="1"/>
            <p:nvPr/>
          </p:nvSpPr>
          <p:spPr>
            <a:xfrm>
              <a:off x="6566108" y="3712211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ZM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2FBCACB-B1BE-AA43-AC2A-23E32B640152}"/>
                </a:ext>
              </a:extLst>
            </p:cNvPr>
            <p:cNvSpPr txBox="1"/>
            <p:nvPr/>
          </p:nvSpPr>
          <p:spPr>
            <a:xfrm>
              <a:off x="5820816" y="4251961"/>
              <a:ext cx="3385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JSM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EAFEB8C-A98E-6A4F-A828-6FF1833BA466}"/>
                </a:ext>
              </a:extLst>
            </p:cNvPr>
            <p:cNvSpPr txBox="1"/>
            <p:nvPr/>
          </p:nvSpPr>
          <p:spPr>
            <a:xfrm>
              <a:off x="5069049" y="3375661"/>
              <a:ext cx="3561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ERM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859EA570-6E35-E741-8DBB-983CEA4A84ED}"/>
                </a:ext>
              </a:extLst>
            </p:cNvPr>
            <p:cNvSpPr txBox="1"/>
            <p:nvPr/>
          </p:nvSpPr>
          <p:spPr>
            <a:xfrm>
              <a:off x="4966803" y="3175636"/>
              <a:ext cx="32573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B336EDA-5B2D-BC45-9F76-D70BB33AC4AD}"/>
                </a:ext>
              </a:extLst>
            </p:cNvPr>
            <p:cNvSpPr txBox="1"/>
            <p:nvPr/>
          </p:nvSpPr>
          <p:spPr>
            <a:xfrm>
              <a:off x="6239854" y="2740661"/>
              <a:ext cx="3513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SPM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1EF661F-3427-E548-B0FD-1F7AE18AF380}"/>
                </a:ext>
              </a:extLst>
            </p:cNvPr>
            <p:cNvSpPr txBox="1"/>
            <p:nvPr/>
          </p:nvSpPr>
          <p:spPr>
            <a:xfrm>
              <a:off x="6038256" y="4315461"/>
              <a:ext cx="3481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LM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3CB0E472-FBF8-9744-853A-69B5C78BACD2}"/>
                </a:ext>
              </a:extLst>
            </p:cNvPr>
            <p:cNvGrpSpPr/>
            <p:nvPr/>
          </p:nvGrpSpPr>
          <p:grpSpPr>
            <a:xfrm>
              <a:off x="5256386" y="2926700"/>
              <a:ext cx="1339850" cy="1374775"/>
              <a:chOff x="6410325" y="2686050"/>
              <a:chExt cx="1339850" cy="1374775"/>
            </a:xfrm>
          </p:grpSpPr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0B857FFD-48DF-DD45-ADF3-84DA6F37C6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11145" y="2960575"/>
                <a:ext cx="356455" cy="7097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9AEFD834-8EB7-2643-A2ED-EBFF757C7F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469920" y="3590925"/>
                <a:ext cx="280255" cy="776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CBEE9F7E-F06D-804A-8AC6-6B5472D5645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359650" y="3667126"/>
                <a:ext cx="111125" cy="2349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8D593E62-FB29-3248-B4B8-C8257268B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65145" y="3900376"/>
                <a:ext cx="0" cy="16044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9389E22D-4A8A-4E4B-BCED-DD5A9D27ED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32650" y="3897201"/>
                <a:ext cx="126145" cy="11917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>
                <a:extLst>
                  <a:ext uri="{FF2B5EF4-FFF2-40B4-BE49-F238E27FC236}">
                    <a16:creationId xmlns:a16="http://schemas.microsoft.com/office/drawing/2014/main" id="{8FCEE04A-311B-1E49-A50A-096D48AA1F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111145" y="2832100"/>
                <a:ext cx="258030" cy="1253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C6E9194A-C8ED-5C47-8DDA-FBC30CBFE49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365145" y="2809875"/>
                <a:ext cx="223105" cy="237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F912083A-C91E-B746-A2A1-D024817C8A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365145" y="2686050"/>
                <a:ext cx="134205" cy="1507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6830580D-1A0A-2B4C-BE23-B6F9C622BBA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826250" y="2901950"/>
                <a:ext cx="284895" cy="5545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F50A729D-C797-BF44-B57D-91EE8945FA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828570" y="2701925"/>
                <a:ext cx="26255" cy="1936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96FA5EFD-6CE7-B248-9AC4-1E0E94B036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13525" y="2900251"/>
                <a:ext cx="215045" cy="9377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6E8CD020-91C7-134B-8A96-578EB753C5B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86525" y="2995501"/>
                <a:ext cx="129320" cy="13187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id="{AB0CACA7-EA84-7842-94AD-903C92EBF93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10325" y="2998676"/>
                <a:ext cx="208695" cy="239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2DF90DE-4266-FD4B-B2CF-438F3772E9E3}"/>
                </a:ext>
              </a:extLst>
            </p:cNvPr>
            <p:cNvGrpSpPr/>
            <p:nvPr/>
          </p:nvGrpSpPr>
          <p:grpSpPr>
            <a:xfrm>
              <a:off x="5441847" y="3051437"/>
              <a:ext cx="893250" cy="1105975"/>
              <a:chOff x="6595786" y="2810787"/>
              <a:chExt cx="893250" cy="1105975"/>
            </a:xfrm>
            <a:solidFill>
              <a:schemeClr val="tx1"/>
            </a:solidFill>
          </p:grpSpPr>
          <p:sp>
            <p:nvSpPr>
              <p:cNvPr id="63" name="Oval 62">
                <a:extLst>
                  <a:ext uri="{FF2B5EF4-FFF2-40B4-BE49-F238E27FC236}">
                    <a16:creationId xmlns:a16="http://schemas.microsoft.com/office/drawing/2014/main" id="{1E27FAFB-C53A-B24A-9C08-160AD06DA4DD}"/>
                  </a:ext>
                </a:extLst>
              </p:cNvPr>
              <p:cNvSpPr/>
              <p:nvPr/>
            </p:nvSpPr>
            <p:spPr>
              <a:xfrm>
                <a:off x="7341911" y="3880762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03" name="Oval 102">
                <a:extLst>
                  <a:ext uri="{FF2B5EF4-FFF2-40B4-BE49-F238E27FC236}">
                    <a16:creationId xmlns:a16="http://schemas.microsoft.com/office/drawing/2014/main" id="{555CD7D6-7492-9849-8482-C6107050A576}"/>
                  </a:ext>
                </a:extLst>
              </p:cNvPr>
              <p:cNvSpPr/>
              <p:nvPr/>
            </p:nvSpPr>
            <p:spPr>
              <a:xfrm>
                <a:off x="7094261" y="2937787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05" name="Oval 104">
                <a:extLst>
                  <a:ext uri="{FF2B5EF4-FFF2-40B4-BE49-F238E27FC236}">
                    <a16:creationId xmlns:a16="http://schemas.microsoft.com/office/drawing/2014/main" id="{5596D000-2B0E-B543-A602-2F5C311476C3}"/>
                  </a:ext>
                </a:extLst>
              </p:cNvPr>
              <p:cNvSpPr/>
              <p:nvPr/>
            </p:nvSpPr>
            <p:spPr>
              <a:xfrm>
                <a:off x="7453036" y="3645812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07" name="Oval 106">
                <a:extLst>
                  <a:ext uri="{FF2B5EF4-FFF2-40B4-BE49-F238E27FC236}">
                    <a16:creationId xmlns:a16="http://schemas.microsoft.com/office/drawing/2014/main" id="{B0AE2A0B-18A0-DD4F-83D5-EC53EADC9CBA}"/>
                  </a:ext>
                </a:extLst>
              </p:cNvPr>
              <p:cNvSpPr/>
              <p:nvPr/>
            </p:nvSpPr>
            <p:spPr>
              <a:xfrm>
                <a:off x="7272061" y="3296562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09" name="Oval 108">
                <a:extLst>
                  <a:ext uri="{FF2B5EF4-FFF2-40B4-BE49-F238E27FC236}">
                    <a16:creationId xmlns:a16="http://schemas.microsoft.com/office/drawing/2014/main" id="{55C8BCCA-5EFF-EF4E-A94A-DD07CC6FFD66}"/>
                  </a:ext>
                </a:extLst>
              </p:cNvPr>
              <p:cNvSpPr/>
              <p:nvPr/>
            </p:nvSpPr>
            <p:spPr>
              <a:xfrm>
                <a:off x="7348261" y="2810787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11" name="Oval 110">
                <a:extLst>
                  <a:ext uri="{FF2B5EF4-FFF2-40B4-BE49-F238E27FC236}">
                    <a16:creationId xmlns:a16="http://schemas.microsoft.com/office/drawing/2014/main" id="{8AE97903-941D-364B-9948-0882B67B6DBA}"/>
                  </a:ext>
                </a:extLst>
              </p:cNvPr>
              <p:cNvSpPr/>
              <p:nvPr/>
            </p:nvSpPr>
            <p:spPr>
              <a:xfrm>
                <a:off x="6808511" y="2883812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12" name="Oval 111">
                <a:extLst>
                  <a:ext uri="{FF2B5EF4-FFF2-40B4-BE49-F238E27FC236}">
                    <a16:creationId xmlns:a16="http://schemas.microsoft.com/office/drawing/2014/main" id="{98AADE80-283E-A74A-9B21-391EA98AD54E}"/>
                  </a:ext>
                </a:extLst>
              </p:cNvPr>
              <p:cNvSpPr/>
              <p:nvPr/>
            </p:nvSpPr>
            <p:spPr>
              <a:xfrm>
                <a:off x="6595786" y="2975887"/>
                <a:ext cx="36000" cy="36000"/>
              </a:xfrm>
              <a:prstGeom prst="ellips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113" name="Oval 112">
              <a:extLst>
                <a:ext uri="{FF2B5EF4-FFF2-40B4-BE49-F238E27FC236}">
                  <a16:creationId xmlns:a16="http://schemas.microsoft.com/office/drawing/2014/main" id="{2D87693A-EB7E-A04E-A202-8A868E57C61E}"/>
                </a:ext>
              </a:extLst>
            </p:cNvPr>
            <p:cNvSpPr/>
            <p:nvPr/>
          </p:nvSpPr>
          <p:spPr>
            <a:xfrm>
              <a:off x="6048007" y="4223989"/>
              <a:ext cx="69156" cy="69156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C847E14A-F96A-C84F-B11B-7E9B6D572453}"/>
                </a:ext>
              </a:extLst>
            </p:cNvPr>
            <p:cNvSpPr/>
            <p:nvPr/>
          </p:nvSpPr>
          <p:spPr>
            <a:xfrm>
              <a:off x="6178182" y="4262089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4" name="Oval 113">
              <a:extLst>
                <a:ext uri="{FF2B5EF4-FFF2-40B4-BE49-F238E27FC236}">
                  <a16:creationId xmlns:a16="http://schemas.microsoft.com/office/drawing/2014/main" id="{E5523C87-4258-F24C-AA38-99ACC0CA161E}"/>
                </a:ext>
              </a:extLst>
            </p:cNvPr>
            <p:cNvSpPr/>
            <p:nvPr/>
          </p:nvSpPr>
          <p:spPr>
            <a:xfrm>
              <a:off x="6559182" y="3795364"/>
              <a:ext cx="69156" cy="69156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5" name="Oval 114">
              <a:extLst>
                <a:ext uri="{FF2B5EF4-FFF2-40B4-BE49-F238E27FC236}">
                  <a16:creationId xmlns:a16="http://schemas.microsoft.com/office/drawing/2014/main" id="{C50B46CB-C9EA-B447-B0AB-42DF5F06B4C8}"/>
                </a:ext>
              </a:extLst>
            </p:cNvPr>
            <p:cNvSpPr/>
            <p:nvPr/>
          </p:nvSpPr>
          <p:spPr>
            <a:xfrm>
              <a:off x="6397257" y="3011139"/>
              <a:ext cx="69156" cy="69156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B0A56DFB-EBB4-4142-8083-7F2F4726AA3D}"/>
                </a:ext>
              </a:extLst>
            </p:cNvPr>
            <p:cNvSpPr/>
            <p:nvPr/>
          </p:nvSpPr>
          <p:spPr>
            <a:xfrm>
              <a:off x="6308357" y="2890489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7351D477-FBB9-5443-9DE7-AF7351397CE7}"/>
                </a:ext>
              </a:extLst>
            </p:cNvPr>
            <p:cNvSpPr/>
            <p:nvPr/>
          </p:nvSpPr>
          <p:spPr>
            <a:xfrm>
              <a:off x="5663832" y="2906364"/>
              <a:ext cx="69156" cy="69156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455F035A-2C80-E44C-B5EC-DDE41AE85899}"/>
                </a:ext>
              </a:extLst>
            </p:cNvPr>
            <p:cNvSpPr/>
            <p:nvPr/>
          </p:nvSpPr>
          <p:spPr>
            <a:xfrm>
              <a:off x="5228857" y="3217514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F5597F57-A668-0D46-A165-D576F0E4A62E}"/>
                </a:ext>
              </a:extLst>
            </p:cNvPr>
            <p:cNvSpPr/>
            <p:nvPr/>
          </p:nvSpPr>
          <p:spPr>
            <a:xfrm>
              <a:off x="5298707" y="3338164"/>
              <a:ext cx="69156" cy="6915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52AF27C6-CB6B-2A44-893C-744398517384}"/>
                </a:ext>
              </a:extLst>
            </p:cNvPr>
            <p:cNvSpPr txBox="1"/>
            <p:nvPr/>
          </p:nvSpPr>
          <p:spPr>
            <a:xfrm>
              <a:off x="3426785" y="2357874"/>
              <a:ext cx="11272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(A) Optical density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CF61C97-E1C4-C449-AEE0-0B905BA5D5C7}"/>
                </a:ext>
              </a:extLst>
            </p:cNvPr>
            <p:cNvSpPr txBox="1"/>
            <p:nvPr/>
          </p:nvSpPr>
          <p:spPr>
            <a:xfrm>
              <a:off x="5339224" y="2357874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Metabolic activ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08223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7</TotalTime>
  <Words>28</Words>
  <Application>Microsoft Macintosh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348</cp:revision>
  <cp:lastPrinted>2018-10-22T15:16:13Z</cp:lastPrinted>
  <dcterms:created xsi:type="dcterms:W3CDTF">2018-10-15T11:58:13Z</dcterms:created>
  <dcterms:modified xsi:type="dcterms:W3CDTF">2021-06-07T14:40:59Z</dcterms:modified>
</cp:coreProperties>
</file>